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30" d="100"/>
          <a:sy n="130" d="100"/>
        </p:scale>
        <p:origin x="1074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1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43608" y="260648"/>
            <a:ext cx="23621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itchFamily="34" charset="0"/>
                <a:cs typeface="Arial" pitchFamily="34" charset="0"/>
              </a:rPr>
              <a:t>Table S1. Primers used for PCR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CCD142C3-6463-4908-B686-AADE4E4B868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3412505"/>
              </p:ext>
            </p:extLst>
          </p:nvPr>
        </p:nvGraphicFramePr>
        <p:xfrm>
          <a:off x="1547664" y="620688"/>
          <a:ext cx="4641114" cy="455657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46323">
                  <a:extLst>
                    <a:ext uri="{9D8B030D-6E8A-4147-A177-3AD203B41FA5}">
                      <a16:colId xmlns:a16="http://schemas.microsoft.com/office/drawing/2014/main" val="630434138"/>
                    </a:ext>
                  </a:extLst>
                </a:gridCol>
                <a:gridCol w="2394791">
                  <a:extLst>
                    <a:ext uri="{9D8B030D-6E8A-4147-A177-3AD203B41FA5}">
                      <a16:colId xmlns:a16="http://schemas.microsoft.com/office/drawing/2014/main" val="3250997321"/>
                    </a:ext>
                  </a:extLst>
                </a:gridCol>
              </a:tblGrid>
              <a:tr h="15606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 dirty="0">
                          <a:effectLst/>
                        </a:rPr>
                        <a:t>primer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 dirty="0">
                          <a:effectLst/>
                        </a:rPr>
                        <a:t>sequence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2422323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kern="1200" dirty="0">
                          <a:effectLst/>
                        </a:rPr>
                        <a:t>total bacteria Forward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>
                          <a:effectLst/>
                        </a:rPr>
                        <a:t>5’-ACTCCTACGGGAGGCAGCAG -3’  </a:t>
                      </a:r>
                      <a:endParaRPr lang="zh-CN" sz="10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5917363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kern="1200" dirty="0">
                          <a:effectLst/>
                        </a:rPr>
                        <a:t>total bacteria Reverse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>
                          <a:effectLst/>
                        </a:rPr>
                        <a:t>5’-ATTACCGCGGCTGCTGG-3’</a:t>
                      </a:r>
                      <a:endParaRPr lang="zh-CN" sz="10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17422810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i="1" kern="1200" dirty="0">
                          <a:effectLst/>
                        </a:rPr>
                        <a:t>Bifidobacterium spp. </a:t>
                      </a:r>
                      <a:r>
                        <a:rPr lang="en-US" sz="900" kern="1200" dirty="0">
                          <a:effectLst/>
                        </a:rPr>
                        <a:t>Forward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>
                          <a:effectLst/>
                        </a:rPr>
                        <a:t>5’-GATTCTGGC TCAGGATGAACGC-3’</a:t>
                      </a:r>
                      <a:endParaRPr lang="zh-CN" sz="10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2462437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i="1" kern="1200" dirty="0">
                          <a:effectLst/>
                        </a:rPr>
                        <a:t>Bifidobacterium spp. </a:t>
                      </a:r>
                      <a:r>
                        <a:rPr lang="en-US" sz="900" kern="1200" dirty="0">
                          <a:effectLst/>
                        </a:rPr>
                        <a:t>Reverse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>
                          <a:effectLst/>
                        </a:rPr>
                        <a:t>5’-CTGATAGGACGCGACCCCAT-3’</a:t>
                      </a:r>
                      <a:endParaRPr lang="zh-CN" sz="10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7238325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i="1" kern="1200" dirty="0">
                          <a:effectLst/>
                        </a:rPr>
                        <a:t>Lactobacillus spp. </a:t>
                      </a:r>
                      <a:r>
                        <a:rPr lang="en-US" sz="900" kern="1200" dirty="0">
                          <a:effectLst/>
                        </a:rPr>
                        <a:t>Forward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>
                          <a:effectLst/>
                        </a:rPr>
                        <a:t>5’-AGCAGTAGGGAATCTTCCA-3’ </a:t>
                      </a:r>
                      <a:endParaRPr lang="zh-CN" sz="10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9963099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i="1" kern="1200" dirty="0">
                          <a:effectLst/>
                        </a:rPr>
                        <a:t>Lactobacillus spp. </a:t>
                      </a:r>
                      <a:r>
                        <a:rPr lang="en-US" sz="900" kern="1200" dirty="0">
                          <a:effectLst/>
                        </a:rPr>
                        <a:t>Reverse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>
                          <a:effectLst/>
                        </a:rPr>
                        <a:t>5’-CACCGCTACACATGGAG-3’ </a:t>
                      </a:r>
                      <a:endParaRPr lang="zh-CN" sz="10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96662873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kern="1200" dirty="0">
                          <a:effectLst/>
                        </a:rPr>
                        <a:t>Fusobacterium </a:t>
                      </a:r>
                      <a:r>
                        <a:rPr lang="en-US" sz="900" i="1" kern="1200" dirty="0" err="1">
                          <a:effectLst/>
                        </a:rPr>
                        <a:t>prausnitzii</a:t>
                      </a:r>
                      <a:r>
                        <a:rPr lang="en-US" sz="900" i="1" kern="1200" dirty="0">
                          <a:effectLst/>
                        </a:rPr>
                        <a:t> </a:t>
                      </a:r>
                      <a:r>
                        <a:rPr lang="en-US" sz="900" kern="1200" dirty="0">
                          <a:effectLst/>
                        </a:rPr>
                        <a:t>Forward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 dirty="0">
                          <a:effectLst/>
                        </a:rPr>
                        <a:t>5’-GAGCCTCAGCGTCAGTTGGT-3’  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84084333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kern="1200" dirty="0">
                          <a:effectLst/>
                        </a:rPr>
                        <a:t>Fusobacterium </a:t>
                      </a:r>
                      <a:r>
                        <a:rPr lang="en-US" sz="900" i="1" kern="1200" dirty="0" err="1">
                          <a:effectLst/>
                        </a:rPr>
                        <a:t>prausnitzii</a:t>
                      </a:r>
                      <a:r>
                        <a:rPr lang="en-US" sz="900" i="1" kern="1200" dirty="0">
                          <a:effectLst/>
                        </a:rPr>
                        <a:t> </a:t>
                      </a:r>
                      <a:r>
                        <a:rPr lang="en-US" sz="900" kern="1200" dirty="0">
                          <a:effectLst/>
                        </a:rPr>
                        <a:t>Reverse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 dirty="0">
                          <a:effectLst/>
                        </a:rPr>
                        <a:t>5’-CCATGAATTGCCTTCAAAACT-3’ 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4684634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i="1" kern="1200" dirty="0">
                          <a:effectLst/>
                        </a:rPr>
                        <a:t>E. coli </a:t>
                      </a:r>
                      <a:r>
                        <a:rPr lang="en-US" sz="900" kern="1200" dirty="0">
                          <a:effectLst/>
                        </a:rPr>
                        <a:t>Forward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 dirty="0">
                          <a:effectLst/>
                        </a:rPr>
                        <a:t>5’-CAAGACATCATGGCCCTTAC-3’ 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9844428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i="1" kern="1200" dirty="0">
                          <a:effectLst/>
                        </a:rPr>
                        <a:t>E. coli </a:t>
                      </a:r>
                      <a:r>
                        <a:rPr lang="en-US" sz="900" kern="1200" dirty="0">
                          <a:effectLst/>
                        </a:rPr>
                        <a:t>Reverse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 dirty="0">
                          <a:effectLst/>
                        </a:rPr>
                        <a:t>5’-ACTTCATGGAGTCGAGTTGC-3’  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2780737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i="1" kern="1200" dirty="0">
                          <a:effectLst/>
                        </a:rPr>
                        <a:t>Clostridium </a:t>
                      </a:r>
                      <a:r>
                        <a:rPr lang="en-US" sz="900" i="1" kern="1200" dirty="0" err="1">
                          <a:effectLst/>
                        </a:rPr>
                        <a:t>coccoides</a:t>
                      </a:r>
                      <a:r>
                        <a:rPr lang="en-US" sz="900" i="1" kern="1200" dirty="0">
                          <a:effectLst/>
                        </a:rPr>
                        <a:t> </a:t>
                      </a:r>
                      <a:r>
                        <a:rPr lang="en-US" sz="900" kern="1200" dirty="0">
                          <a:effectLst/>
                        </a:rPr>
                        <a:t>Forward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 dirty="0">
                          <a:effectLst/>
                        </a:rPr>
                        <a:t>5’-AAATGACGGTACCTGACTAA-3’ 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7135226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i="1" kern="1200" dirty="0">
                          <a:effectLst/>
                        </a:rPr>
                        <a:t>Clostridium </a:t>
                      </a:r>
                      <a:r>
                        <a:rPr lang="en-US" sz="900" i="1" kern="1200" dirty="0" err="1">
                          <a:effectLst/>
                        </a:rPr>
                        <a:t>coccoides</a:t>
                      </a:r>
                      <a:r>
                        <a:rPr lang="en-US" sz="900" i="1" kern="1200" dirty="0">
                          <a:effectLst/>
                        </a:rPr>
                        <a:t> </a:t>
                      </a:r>
                      <a:r>
                        <a:rPr lang="en-US" sz="900" kern="1200" dirty="0">
                          <a:effectLst/>
                        </a:rPr>
                        <a:t>Reverse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 dirty="0">
                          <a:effectLst/>
                        </a:rPr>
                        <a:t>5’-CTTTGAGTTTCATTCTTGCGAA-3’ 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737555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i="1" kern="1200" dirty="0">
                          <a:effectLst/>
                        </a:rPr>
                        <a:t>Bacteroides </a:t>
                      </a:r>
                      <a:r>
                        <a:rPr lang="en-US" sz="900" i="1" kern="1200" dirty="0" err="1">
                          <a:effectLst/>
                        </a:rPr>
                        <a:t>spp</a:t>
                      </a:r>
                      <a:r>
                        <a:rPr lang="en-US" sz="900" i="1" kern="1200" dirty="0">
                          <a:effectLst/>
                        </a:rPr>
                        <a:t> </a:t>
                      </a:r>
                      <a:r>
                        <a:rPr lang="en-US" sz="900" kern="1200" dirty="0">
                          <a:effectLst/>
                        </a:rPr>
                        <a:t>Forward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 dirty="0">
                          <a:effectLst/>
                        </a:rPr>
                        <a:t>5’-TGACAGTGAGAGATTTGCTGCGTT-3’ 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23865583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i="1" kern="1200" dirty="0">
                          <a:effectLst/>
                        </a:rPr>
                        <a:t>Bacteroides </a:t>
                      </a:r>
                      <a:r>
                        <a:rPr lang="en-US" sz="900" i="1" kern="1200" dirty="0" err="1">
                          <a:effectLst/>
                        </a:rPr>
                        <a:t>spp</a:t>
                      </a:r>
                      <a:r>
                        <a:rPr lang="en-US" sz="900" i="1" kern="1200" dirty="0">
                          <a:effectLst/>
                        </a:rPr>
                        <a:t> </a:t>
                      </a:r>
                      <a:r>
                        <a:rPr lang="en-US" sz="900" kern="1200" dirty="0">
                          <a:effectLst/>
                        </a:rPr>
                        <a:t>Reverse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 dirty="0">
                          <a:effectLst/>
                        </a:rPr>
                        <a:t>5’-CAAGACATCATGGCCCTTAC-3’ 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35963845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kern="1200">
                          <a:effectLst/>
                        </a:rPr>
                        <a:t>ZO-1 Forward</a:t>
                      </a:r>
                      <a:endParaRPr lang="zh-CN" sz="10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 dirty="0">
                          <a:effectLst/>
                        </a:rPr>
                        <a:t>5’-TTCTTGCAAAGTATCCCTTCTG-3’  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73681305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kern="1200">
                          <a:effectLst/>
                        </a:rPr>
                        <a:t>ZO-1 Reverse</a:t>
                      </a:r>
                      <a:endParaRPr lang="zh-CN" sz="10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 dirty="0">
                          <a:effectLst/>
                        </a:rPr>
                        <a:t>5’-CCACAAAAGAAATCCTTTCACA-3’ 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47382388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i="1" kern="1200" dirty="0" err="1">
                          <a:effectLst/>
                        </a:rPr>
                        <a:t>occlaudin</a:t>
                      </a:r>
                      <a:r>
                        <a:rPr lang="en-US" sz="900" kern="1200" dirty="0">
                          <a:effectLst/>
                        </a:rPr>
                        <a:t> Forward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 dirty="0">
                          <a:effectLst/>
                        </a:rPr>
                        <a:t>5’-GACTGGGTCAGGGAATATCCACC-3’ 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208120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i="1" kern="1200" dirty="0" err="1">
                          <a:effectLst/>
                        </a:rPr>
                        <a:t>occlaudin</a:t>
                      </a:r>
                      <a:r>
                        <a:rPr lang="en-US" sz="900" kern="1200" dirty="0">
                          <a:effectLst/>
                        </a:rPr>
                        <a:t> Reverse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 dirty="0">
                          <a:effectLst/>
                        </a:rPr>
                        <a:t>5’-AGCAGCAGCCATGTACTCTTCAC-3’ 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57133962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1" kern="1200" dirty="0">
                          <a:effectLst/>
                        </a:rPr>
                        <a:t>claudin1</a:t>
                      </a:r>
                      <a:r>
                        <a:rPr lang="en-US" sz="900" kern="1200" dirty="0">
                          <a:effectLst/>
                        </a:rPr>
                        <a:t> Forward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 dirty="0">
                          <a:effectLst/>
                        </a:rPr>
                        <a:t>5’-GCTAAGCTGCTAACCCTGTGGT-3’ 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2842822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i="1" kern="1200" dirty="0">
                          <a:effectLst/>
                        </a:rPr>
                        <a:t>claudin1</a:t>
                      </a:r>
                      <a:r>
                        <a:rPr lang="en-US" sz="900" kern="1200" dirty="0">
                          <a:effectLst/>
                        </a:rPr>
                        <a:t> Reverse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 dirty="0">
                          <a:effectLst/>
                        </a:rPr>
                        <a:t>5’-TCTGGCAAGTCTAGCAGTTTGTG-3’ 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2795192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i="1" kern="1200" dirty="0">
                          <a:effectLst/>
                        </a:rPr>
                        <a:t>TNF-α</a:t>
                      </a:r>
                      <a:r>
                        <a:rPr lang="en-US" sz="900" kern="1200" dirty="0">
                          <a:effectLst/>
                        </a:rPr>
                        <a:t> Forward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kern="100" dirty="0">
                          <a:effectLst/>
                        </a:rPr>
                        <a:t>5’-GAGATGTGGAACTGGCAGAG-3’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74437038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i="1" kern="1200" dirty="0">
                          <a:effectLst/>
                        </a:rPr>
                        <a:t>TNF-α</a:t>
                      </a:r>
                      <a:r>
                        <a:rPr lang="en-US" sz="900" kern="1200" dirty="0">
                          <a:effectLst/>
                        </a:rPr>
                        <a:t> Reverse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kern="100" dirty="0">
                          <a:effectLst/>
                        </a:rPr>
                        <a:t>5’-AGCAGGAATGAGAAGAGGCT-3’ 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412707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i="1" kern="1200" dirty="0">
                          <a:effectLst/>
                        </a:rPr>
                        <a:t>IL-1β</a:t>
                      </a:r>
                      <a:r>
                        <a:rPr lang="en-US" sz="900" kern="1200" dirty="0">
                          <a:effectLst/>
                        </a:rPr>
                        <a:t> Forward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kern="100" dirty="0">
                          <a:effectLst/>
                        </a:rPr>
                        <a:t>5’-GCATCCAGCTTCAAATCTCA-3’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2664033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i="1" kern="1200" dirty="0">
                          <a:effectLst/>
                        </a:rPr>
                        <a:t>IL-1β</a:t>
                      </a:r>
                      <a:r>
                        <a:rPr lang="en-US" sz="900" kern="1200" dirty="0">
                          <a:effectLst/>
                        </a:rPr>
                        <a:t> Reverse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kern="100" dirty="0">
                          <a:effectLst/>
                        </a:rPr>
                        <a:t>5’-ACGGGCAAGACATAGGTAGC-3’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68739549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i="1" kern="1200" dirty="0">
                          <a:effectLst/>
                        </a:rPr>
                        <a:t>IL-6</a:t>
                      </a:r>
                      <a:r>
                        <a:rPr lang="en-US" sz="900" kern="1200" dirty="0">
                          <a:effectLst/>
                        </a:rPr>
                        <a:t> Forward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kern="100" dirty="0">
                          <a:effectLst/>
                        </a:rPr>
                        <a:t>5’-AAGGACCAAGACCATCCAAC -3’  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6425211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i="1" kern="1200" dirty="0">
                          <a:effectLst/>
                        </a:rPr>
                        <a:t>IL-6</a:t>
                      </a:r>
                      <a:r>
                        <a:rPr lang="en-US" sz="900" kern="1200" dirty="0">
                          <a:effectLst/>
                        </a:rPr>
                        <a:t> Reverse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kern="100" dirty="0">
                          <a:effectLst/>
                        </a:rPr>
                        <a:t>5’-ACCACAGTGAGGAATGTCCA-3’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7137004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i="1" kern="1200" dirty="0">
                          <a:effectLst/>
                        </a:rPr>
                        <a:t>GAPDH</a:t>
                      </a:r>
                      <a:r>
                        <a:rPr lang="en-US" sz="900" kern="1200" dirty="0">
                          <a:effectLst/>
                        </a:rPr>
                        <a:t> Forward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 dirty="0">
                          <a:effectLst/>
                        </a:rPr>
                        <a:t>5’-GGAGCGAGATCCCGTCAAGA-3’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8014724"/>
                  </a:ext>
                </a:extLst>
              </a:tr>
              <a:tr h="156068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i="1" kern="1200" dirty="0">
                          <a:effectLst/>
                        </a:rPr>
                        <a:t>GAPDH</a:t>
                      </a:r>
                      <a:r>
                        <a:rPr lang="en-US" sz="900" kern="1200" dirty="0">
                          <a:effectLst/>
                        </a:rPr>
                        <a:t> Reverse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kern="1200" dirty="0">
                          <a:effectLst/>
                        </a:rPr>
                        <a:t>5’-CACAAACATGGGGGCATCAG-3’</a:t>
                      </a:r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768" marR="8768" marT="876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537304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389817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202</Words>
  <Application>Microsoft Office PowerPoint</Application>
  <PresentationFormat>全屏显示(4:3)</PresentationFormat>
  <Paragraphs>5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Arial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changxulu19@163.com</cp:lastModifiedBy>
  <cp:revision>9</cp:revision>
  <dcterms:created xsi:type="dcterms:W3CDTF">2019-11-15T01:34:31Z</dcterms:created>
  <dcterms:modified xsi:type="dcterms:W3CDTF">2020-12-21T08:10:11Z</dcterms:modified>
</cp:coreProperties>
</file>